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328" r:id="rId3"/>
    <p:sldId id="329" r:id="rId4"/>
    <p:sldId id="258" r:id="rId5"/>
    <p:sldId id="262" r:id="rId6"/>
    <p:sldId id="330" r:id="rId7"/>
    <p:sldId id="334" r:id="rId8"/>
    <p:sldId id="335" r:id="rId9"/>
    <p:sldId id="336" r:id="rId10"/>
    <p:sldId id="337" r:id="rId11"/>
    <p:sldId id="338" r:id="rId12"/>
    <p:sldId id="339" r:id="rId13"/>
    <p:sldId id="340" r:id="rId14"/>
    <p:sldId id="341" r:id="rId15"/>
    <p:sldId id="342" r:id="rId16"/>
    <p:sldId id="343" r:id="rId17"/>
    <p:sldId id="344" r:id="rId18"/>
    <p:sldId id="331" r:id="rId19"/>
    <p:sldId id="332" r:id="rId20"/>
    <p:sldId id="333" r:id="rId21"/>
    <p:sldId id="345" r:id="rId22"/>
    <p:sldId id="346" r:id="rId23"/>
    <p:sldId id="347" r:id="rId24"/>
    <p:sldId id="348" r:id="rId25"/>
    <p:sldId id="349" r:id="rId26"/>
    <p:sldId id="350" r:id="rId27"/>
    <p:sldId id="351" r:id="rId28"/>
    <p:sldId id="256" r:id="rId29"/>
    <p:sldId id="352" r:id="rId30"/>
    <p:sldId id="353" r:id="rId31"/>
    <p:sldId id="354" r:id="rId32"/>
    <p:sldId id="355" r:id="rId33"/>
    <p:sldId id="356" r:id="rId34"/>
    <p:sldId id="357" r:id="rId35"/>
    <p:sldId id="358" r:id="rId36"/>
    <p:sldId id="359" r:id="rId37"/>
    <p:sldId id="360" r:id="rId38"/>
    <p:sldId id="361" r:id="rId39"/>
    <p:sldId id="260" r:id="rId40"/>
    <p:sldId id="362" r:id="rId41"/>
    <p:sldId id="363" r:id="rId42"/>
    <p:sldId id="364" r:id="rId43"/>
    <p:sldId id="365" r:id="rId44"/>
    <p:sldId id="366" r:id="rId45"/>
    <p:sldId id="367" r:id="rId46"/>
    <p:sldId id="368" r:id="rId47"/>
    <p:sldId id="369" r:id="rId48"/>
    <p:sldId id="370" r:id="rId49"/>
    <p:sldId id="371" r:id="rId50"/>
    <p:sldId id="372" r:id="rId51"/>
    <p:sldId id="373" r:id="rId52"/>
    <p:sldId id="374" r:id="rId53"/>
    <p:sldId id="279" r:id="rId54"/>
    <p:sldId id="277" r:id="rId55"/>
    <p:sldId id="375" r:id="rId56"/>
    <p:sldId id="376" r:id="rId57"/>
    <p:sldId id="377" r:id="rId58"/>
    <p:sldId id="378" r:id="rId59"/>
    <p:sldId id="379" r:id="rId60"/>
    <p:sldId id="380" r:id="rId61"/>
    <p:sldId id="381" r:id="rId62"/>
    <p:sldId id="382" r:id="rId63"/>
    <p:sldId id="317" r:id="rId64"/>
    <p:sldId id="316" r:id="rId65"/>
    <p:sldId id="322" r:id="rId66"/>
    <p:sldId id="321" r:id="rId67"/>
    <p:sldId id="261" r:id="rId68"/>
    <p:sldId id="315" r:id="rId69"/>
    <p:sldId id="278" r:id="rId70"/>
    <p:sldId id="286" r:id="rId71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8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25749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2788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10816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8755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85371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3966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346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893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5804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1338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014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19553-8F3E-45C2-B848-4B09E87BD690}" type="datetimeFigureOut">
              <a:rPr lang="en-AU" smtClean="0"/>
              <a:t>20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E5498-9F85-4887-BE9D-7390CE15B60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3929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4" y="0"/>
            <a:ext cx="12096763" cy="6872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09653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2536" y="0"/>
            <a:ext cx="876692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35307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113" y="170341"/>
            <a:ext cx="10639773" cy="6517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3542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200" y="25401"/>
            <a:ext cx="10414000" cy="6800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094457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3667" y="25401"/>
            <a:ext cx="7759423" cy="6798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416752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6576" y="0"/>
            <a:ext cx="61988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355444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919" y="0"/>
            <a:ext cx="949154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5560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5803" y="0"/>
            <a:ext cx="690591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204209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2038" y="0"/>
            <a:ext cx="770792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792131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5435" y="19341"/>
            <a:ext cx="7795498" cy="68193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90372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9014" y="0"/>
            <a:ext cx="665629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83666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78" y="0"/>
            <a:ext cx="1208882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366857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4796" y="0"/>
            <a:ext cx="576617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973450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662" y="313488"/>
            <a:ext cx="8277225" cy="586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04166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561" y="0"/>
            <a:ext cx="74902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303714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2218" y="0"/>
            <a:ext cx="55321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912560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2919" y="0"/>
            <a:ext cx="691746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117116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870" y="33868"/>
            <a:ext cx="9582566" cy="67753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329389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4862" y="0"/>
            <a:ext cx="908259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545394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6038" y="0"/>
            <a:ext cx="756210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14531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0215" y="0"/>
            <a:ext cx="97915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836596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426" y="250773"/>
            <a:ext cx="10058400" cy="5845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3801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2163" y="0"/>
            <a:ext cx="57632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50670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931" y="0"/>
            <a:ext cx="95528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215914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976" y="0"/>
            <a:ext cx="48140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650441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2655" y="0"/>
            <a:ext cx="77466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5524513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589" y="277284"/>
            <a:ext cx="8829675" cy="6038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288211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5784" y="0"/>
            <a:ext cx="862755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3466883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627" y="1"/>
            <a:ext cx="1018333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656695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1612" y="0"/>
            <a:ext cx="92487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30585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9332" y="-1"/>
            <a:ext cx="9467268" cy="6856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768379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190" y="0"/>
            <a:ext cx="878962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172574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6474" y="0"/>
            <a:ext cx="607890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84976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745" y="30520"/>
            <a:ext cx="10206509" cy="6796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7870350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1865" y="0"/>
            <a:ext cx="69500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35685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0776" y="0"/>
            <a:ext cx="9328224" cy="68584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3639515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2545" y="0"/>
            <a:ext cx="101865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077887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679" y="0"/>
            <a:ext cx="54989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666177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8587" y="0"/>
            <a:ext cx="749781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3382498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860" y="0"/>
            <a:ext cx="986028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5381236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5615" y="0"/>
            <a:ext cx="674076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20904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935" y="381000"/>
            <a:ext cx="10422798" cy="55535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353033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209" y="252412"/>
            <a:ext cx="9759458" cy="6430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1850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4266" y="0"/>
            <a:ext cx="6054012" cy="6862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53619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8886" y="0"/>
            <a:ext cx="748788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920968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773" y="0"/>
            <a:ext cx="97584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826354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1200" y="61819"/>
            <a:ext cx="8146664" cy="67453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530686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427" y="0"/>
            <a:ext cx="904514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699412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4393" y="0"/>
            <a:ext cx="60975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9338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725" y="0"/>
            <a:ext cx="655654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692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9287" y="211113"/>
            <a:ext cx="6905625" cy="563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8663067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3951" y="254845"/>
            <a:ext cx="7296150" cy="5581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1377540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7609" y="556603"/>
            <a:ext cx="8210550" cy="5514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8971529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637" y="590550"/>
            <a:ext cx="9610725" cy="5676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228110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719" y="0"/>
            <a:ext cx="524861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61329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9308" y="0"/>
            <a:ext cx="739338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1292869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2757" y="31530"/>
            <a:ext cx="642648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186749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187" y="0"/>
            <a:ext cx="56656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5278089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734" y="0"/>
            <a:ext cx="858818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85695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862" y="0"/>
            <a:ext cx="953319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332710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253" y="0"/>
            <a:ext cx="907601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3546598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536" y="259799"/>
            <a:ext cx="10058400" cy="63384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4620970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267" y="0"/>
            <a:ext cx="982362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1538063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8467"/>
            <a:ext cx="10076164" cy="68293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4364865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6210" y="0"/>
            <a:ext cx="536850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7409505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9912" y="0"/>
            <a:ext cx="55521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14235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4861" y="669083"/>
            <a:ext cx="10058400" cy="4930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2200316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0875" y="206388"/>
            <a:ext cx="4762500" cy="6038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62535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6677" y="0"/>
            <a:ext cx="677162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1444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844" y="73749"/>
            <a:ext cx="10457612" cy="65895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8711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9</TotalTime>
  <Words>0</Words>
  <Application>Microsoft Office PowerPoint</Application>
  <PresentationFormat>Widescreen</PresentationFormat>
  <Paragraphs>0</Paragraphs>
  <Slides>7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0</vt:i4>
      </vt:variant>
    </vt:vector>
  </HeadingPairs>
  <TitlesOfParts>
    <vt:vector size="7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Queens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imalan Rangan</dc:creator>
  <cp:lastModifiedBy>Parimalan Rangan</cp:lastModifiedBy>
  <cp:revision>30</cp:revision>
  <cp:lastPrinted>2015-10-18T23:28:47Z</cp:lastPrinted>
  <dcterms:created xsi:type="dcterms:W3CDTF">2015-10-12T11:02:11Z</dcterms:created>
  <dcterms:modified xsi:type="dcterms:W3CDTF">2016-08-20T05:06:17Z</dcterms:modified>
</cp:coreProperties>
</file>